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21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24" roundtripDataSignature="AMtx7mg4FATPniOvtJ21dTYyxFY24Blq+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778" y="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customschemas.google.com/relationships/presentationmetadata" Target="metadata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7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Nº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6" name="Google Shape;86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Google Shape;167;p1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68" name="Google Shape;168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Google Shape;176;p1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77" name="Google Shape;177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Google Shape;185;p1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86" name="Google Shape;186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" name="Google Shape;194;p1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95" name="Google Shape;195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Google Shape;203;p1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04" name="Google Shape;204;p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Google Shape;212;p1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13" name="Google Shape;213;p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1" name="Google Shape;221;p1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22" name="Google Shape;222;p1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Google Shape;230;p1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31" name="Google Shape;231;p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Google Shape;239;p1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40" name="Google Shape;240;p1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41" name="Google Shape;241;p18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8</a:t>
            </a:fld>
            <a:endParaRPr/>
          </a:p>
        </p:txBody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9" name="Google Shape;249;p1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50" name="Google Shape;250;p1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Google Shape;94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5" name="Google Shape;95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Google Shape;103;p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4" name="Google Shape;104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13" name="Google Shape;113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Google Shape;121;p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22" name="Google Shape;122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Google Shape;130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31" name="Google Shape;131;p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32" name="Google Shape;132;p6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6</a:t>
            </a:fld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Google Shape;140;p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1" name="Google Shape;141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Google Shape;149;p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50" name="Google Shape;150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Google Shape;158;p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59" name="Google Shape;159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a de título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21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21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8" name="Google Shape;18;p2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2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2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y texto vertical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30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30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3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3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3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vertical y texto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31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31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3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3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3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y objetos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2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2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2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2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2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ncabezado de sección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23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23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2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2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2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os objetos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2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2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24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2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2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2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ció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25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25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25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25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25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2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2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2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olo el título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2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2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2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n blanco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2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2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ido con título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8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8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1" name="Google Shape;61;p28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2" name="Google Shape;62;p2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n con título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9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9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9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9" name="Google Shape;69;p2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0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20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0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2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4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6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8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0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2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2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5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Google Shape;88;p1"/>
          <p:cNvSpPr txBox="1"/>
          <p:nvPr/>
        </p:nvSpPr>
        <p:spPr>
          <a:xfrm>
            <a:off x="1823953" y="1026367"/>
            <a:ext cx="248946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) GSE6575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9" name="Google Shape;89;p1"/>
          <p:cNvSpPr txBox="1"/>
          <p:nvPr/>
        </p:nvSpPr>
        <p:spPr>
          <a:xfrm>
            <a:off x="4888164" y="370277"/>
            <a:ext cx="2989986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utism Spectrum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0" name="Google Shape;90;p1"/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atmaps showing the differentially expressed genes after Empirical Bayes analysis (raw p-value &lt; 0.05)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91" name="Google Shape;91;p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552907" y="2007629"/>
            <a:ext cx="5625964" cy="3824004"/>
          </a:xfrm>
          <a:prstGeom prst="rect">
            <a:avLst/>
          </a:prstGeom>
          <a:noFill/>
          <a:ln>
            <a:noFill/>
          </a:ln>
        </p:spPr>
      </p:pic>
      <p:pic>
        <p:nvPicPr>
          <p:cNvPr id="92" name="Google Shape;92;p1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645862" y="1395699"/>
            <a:ext cx="5036774" cy="419731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Google Shape;170;p10"/>
          <p:cNvSpPr txBox="1"/>
          <p:nvPr/>
        </p:nvSpPr>
        <p:spPr>
          <a:xfrm>
            <a:off x="1823953" y="1026367"/>
            <a:ext cx="258885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j) GSE12654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1" name="Google Shape;171;p10"/>
          <p:cNvSpPr txBox="1"/>
          <p:nvPr/>
        </p:nvSpPr>
        <p:spPr>
          <a:xfrm>
            <a:off x="4888164" y="370277"/>
            <a:ext cx="302320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ajor Depressive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2" name="Google Shape;172;p10"/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atmaps showing the differentially expressed genes after Empirical Bayes analysis (raw p-value &lt; 0.05)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73" name="Google Shape;173;p10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85543" y="1722670"/>
            <a:ext cx="5465670" cy="3931654"/>
          </a:xfrm>
          <a:prstGeom prst="rect">
            <a:avLst/>
          </a:prstGeom>
          <a:noFill/>
          <a:ln>
            <a:noFill/>
          </a:ln>
        </p:spPr>
      </p:pic>
      <p:sp>
        <p:nvSpPr>
          <p:cNvPr id="174" name="Google Shape;174;p10"/>
          <p:cNvSpPr txBox="1"/>
          <p:nvPr/>
        </p:nvSpPr>
        <p:spPr>
          <a:xfrm>
            <a:off x="6399764" y="3059668"/>
            <a:ext cx="5322487" cy="8617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o genes available</a:t>
            </a:r>
            <a:endParaRPr sz="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Google Shape;179;p11"/>
          <p:cNvSpPr txBox="1"/>
          <p:nvPr/>
        </p:nvSpPr>
        <p:spPr>
          <a:xfrm>
            <a:off x="1823953" y="1026367"/>
            <a:ext cx="3095399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k) GSE53987_HPC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0" name="Google Shape;180;p11"/>
          <p:cNvSpPr txBox="1"/>
          <p:nvPr/>
        </p:nvSpPr>
        <p:spPr>
          <a:xfrm>
            <a:off x="4888164" y="370277"/>
            <a:ext cx="167142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chizophrenia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1" name="Google Shape;181;p11"/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atmaps showing the differentially expressed genes after Empirical Bayes analysis (raw p-value &lt; 0.05)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82" name="Google Shape;182;p1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641832" y="1651679"/>
            <a:ext cx="5441468" cy="3945558"/>
          </a:xfrm>
          <a:prstGeom prst="rect">
            <a:avLst/>
          </a:prstGeom>
          <a:noFill/>
          <a:ln>
            <a:noFill/>
          </a:ln>
        </p:spPr>
      </p:pic>
      <p:pic>
        <p:nvPicPr>
          <p:cNvPr id="183" name="Google Shape;183;p11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083300" y="969279"/>
            <a:ext cx="5860724" cy="4883937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8" name="Google Shape;188;p12"/>
          <p:cNvSpPr txBox="1"/>
          <p:nvPr/>
        </p:nvSpPr>
        <p:spPr>
          <a:xfrm>
            <a:off x="1823953" y="1026367"/>
            <a:ext cx="3095399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) GSE53987_HPC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9" name="Google Shape;189;p12"/>
          <p:cNvSpPr txBox="1"/>
          <p:nvPr/>
        </p:nvSpPr>
        <p:spPr>
          <a:xfrm>
            <a:off x="4888164" y="370277"/>
            <a:ext cx="1893532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ipolar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0" name="Google Shape;190;p12"/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atmaps showing the differentially expressed genes after Empirical Bayes analysis (raw p-value &lt; 0.05)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91" name="Google Shape;191;p12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69749" y="1536604"/>
            <a:ext cx="5494852" cy="3949796"/>
          </a:xfrm>
          <a:prstGeom prst="rect">
            <a:avLst/>
          </a:prstGeom>
          <a:noFill/>
          <a:ln>
            <a:noFill/>
          </a:ln>
        </p:spPr>
      </p:pic>
      <p:pic>
        <p:nvPicPr>
          <p:cNvPr id="192" name="Google Shape;192;p12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227401" y="1235490"/>
            <a:ext cx="5494852" cy="457904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Google Shape;197;p13"/>
          <p:cNvSpPr txBox="1"/>
          <p:nvPr/>
        </p:nvSpPr>
        <p:spPr>
          <a:xfrm>
            <a:off x="1823953" y="1026367"/>
            <a:ext cx="318677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) GSE53987_HPC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8" name="Google Shape;198;p13"/>
          <p:cNvSpPr txBox="1"/>
          <p:nvPr/>
        </p:nvSpPr>
        <p:spPr>
          <a:xfrm>
            <a:off x="4888164" y="370277"/>
            <a:ext cx="302320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ajor Depressive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9" name="Google Shape;199;p13"/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atmaps showing the differentially expressed genes after Empirical Bayes analysis (raw p-value &lt; 0.05)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00" name="Google Shape;200;p13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79188" y="1536604"/>
            <a:ext cx="5744984" cy="4117720"/>
          </a:xfrm>
          <a:prstGeom prst="rect">
            <a:avLst/>
          </a:prstGeom>
          <a:noFill/>
          <a:ln>
            <a:noFill/>
          </a:ln>
        </p:spPr>
      </p:pic>
      <p:pic>
        <p:nvPicPr>
          <p:cNvPr id="201" name="Google Shape;201;p13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495727" y="1395699"/>
            <a:ext cx="5155190" cy="429599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" name="Google Shape;206;p14"/>
          <p:cNvSpPr txBox="1"/>
          <p:nvPr/>
        </p:nvSpPr>
        <p:spPr>
          <a:xfrm>
            <a:off x="1823953" y="1026367"/>
            <a:ext cx="3205365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) GSE53987_PFC GEO dataset</a:t>
            </a:r>
            <a:endParaRPr sz="1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07" name="Google Shape;207;p14"/>
          <p:cNvSpPr txBox="1"/>
          <p:nvPr/>
        </p:nvSpPr>
        <p:spPr>
          <a:xfrm>
            <a:off x="4888164" y="370277"/>
            <a:ext cx="167142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chizophrenia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08" name="Google Shape;208;p14"/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atmaps showing the differentially expressed genes after Empirical Bayes analysis (raw p-value &lt; 0.05)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09" name="Google Shape;209;p14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79188" y="1395698"/>
            <a:ext cx="5873230" cy="4258625"/>
          </a:xfrm>
          <a:prstGeom prst="rect">
            <a:avLst/>
          </a:prstGeom>
          <a:noFill/>
          <a:ln>
            <a:noFill/>
          </a:ln>
        </p:spPr>
      </p:pic>
      <p:pic>
        <p:nvPicPr>
          <p:cNvPr id="210" name="Google Shape;210;p14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298883" y="1395698"/>
            <a:ext cx="5244438" cy="437036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Google Shape;215;p15"/>
          <p:cNvSpPr txBox="1"/>
          <p:nvPr/>
        </p:nvSpPr>
        <p:spPr>
          <a:xfrm>
            <a:off x="1823953" y="1026367"/>
            <a:ext cx="3205365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) GSE53987_PFC GEO dataset</a:t>
            </a:r>
            <a:endParaRPr sz="1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6" name="Google Shape;216;p15"/>
          <p:cNvSpPr txBox="1"/>
          <p:nvPr/>
        </p:nvSpPr>
        <p:spPr>
          <a:xfrm>
            <a:off x="4888164" y="370277"/>
            <a:ext cx="1893532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ipolar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7" name="Google Shape;217;p15"/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atmaps showing the differentially expressed genes after Empirical Bayes analysis (raw p-value &lt; 0.05)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18" name="Google Shape;218;p15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69749" y="1395699"/>
            <a:ext cx="5585647" cy="4047158"/>
          </a:xfrm>
          <a:prstGeom prst="rect">
            <a:avLst/>
          </a:prstGeom>
          <a:noFill/>
          <a:ln>
            <a:noFill/>
          </a:ln>
        </p:spPr>
      </p:pic>
      <p:pic>
        <p:nvPicPr>
          <p:cNvPr id="219" name="Google Shape;219;p15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383522" y="993916"/>
            <a:ext cx="5338729" cy="444894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4" name="Google Shape;224;p16"/>
          <p:cNvSpPr txBox="1"/>
          <p:nvPr/>
        </p:nvSpPr>
        <p:spPr>
          <a:xfrm>
            <a:off x="1823953" y="1026367"/>
            <a:ext cx="3205365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) GSE53987_PFC GEO dataset</a:t>
            </a:r>
            <a:endParaRPr sz="1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25" name="Google Shape;225;p16"/>
          <p:cNvSpPr txBox="1"/>
          <p:nvPr/>
        </p:nvSpPr>
        <p:spPr>
          <a:xfrm>
            <a:off x="4888164" y="370277"/>
            <a:ext cx="302320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ajor Depressive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26" name="Google Shape;226;p16"/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atmaps showing the differentially expressed genes after Empirical Bayes analysis (raw p-value &lt; 0.05)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27" name="Google Shape;227;p16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69748" y="1536604"/>
            <a:ext cx="5613551" cy="4100154"/>
          </a:xfrm>
          <a:prstGeom prst="rect">
            <a:avLst/>
          </a:prstGeom>
          <a:noFill/>
          <a:ln>
            <a:noFill/>
          </a:ln>
        </p:spPr>
      </p:pic>
      <p:pic>
        <p:nvPicPr>
          <p:cNvPr id="228" name="Google Shape;228;p16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230106" y="1273110"/>
            <a:ext cx="5734954" cy="477912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Google Shape;233;p17"/>
          <p:cNvSpPr txBox="1"/>
          <p:nvPr/>
        </p:nvSpPr>
        <p:spPr>
          <a:xfrm>
            <a:off x="1823952" y="1026367"/>
            <a:ext cx="336416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q) GSE53987_STR GEO dataset</a:t>
            </a:r>
            <a:endParaRPr sz="1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34" name="Google Shape;234;p17"/>
          <p:cNvSpPr txBox="1"/>
          <p:nvPr/>
        </p:nvSpPr>
        <p:spPr>
          <a:xfrm>
            <a:off x="4888164" y="370277"/>
            <a:ext cx="167142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chizophrenia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35" name="Google Shape;235;p17"/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atmaps showing the differentially expressed genes after Empirical Bayes analysis (raw p-value &lt; 0.05)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36" name="Google Shape;236;p17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526082" y="1471899"/>
            <a:ext cx="5542070" cy="3869358"/>
          </a:xfrm>
          <a:prstGeom prst="rect">
            <a:avLst/>
          </a:prstGeom>
          <a:noFill/>
          <a:ln>
            <a:noFill/>
          </a:ln>
        </p:spPr>
      </p:pic>
      <p:pic>
        <p:nvPicPr>
          <p:cNvPr id="237" name="Google Shape;237;p17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096000" y="1211033"/>
            <a:ext cx="5542070" cy="461839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Google Shape;243;p18"/>
          <p:cNvSpPr txBox="1"/>
          <p:nvPr/>
        </p:nvSpPr>
        <p:spPr>
          <a:xfrm>
            <a:off x="1823953" y="1026367"/>
            <a:ext cx="305468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) GSE53987_STR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44" name="Google Shape;244;p18"/>
          <p:cNvSpPr txBox="1"/>
          <p:nvPr/>
        </p:nvSpPr>
        <p:spPr>
          <a:xfrm>
            <a:off x="4888164" y="370277"/>
            <a:ext cx="1893532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ipolar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45" name="Google Shape;245;p18"/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atmaps showing the differentially expressed genes after Empirical Bayes analysis (raw p-value &lt; 0.05)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46" name="Google Shape;246;p18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721155" y="1536604"/>
            <a:ext cx="5284590" cy="3862710"/>
          </a:xfrm>
          <a:prstGeom prst="rect">
            <a:avLst/>
          </a:prstGeom>
          <a:noFill/>
          <a:ln>
            <a:noFill/>
          </a:ln>
        </p:spPr>
      </p:pic>
      <p:pic>
        <p:nvPicPr>
          <p:cNvPr id="247" name="Google Shape;247;p18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194136" y="1266046"/>
            <a:ext cx="5284590" cy="440382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2" name="Google Shape;252;p19"/>
          <p:cNvSpPr txBox="1"/>
          <p:nvPr/>
        </p:nvSpPr>
        <p:spPr>
          <a:xfrm>
            <a:off x="1823953" y="1026367"/>
            <a:ext cx="305468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) GSE53987_STR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53" name="Google Shape;253;p19"/>
          <p:cNvSpPr txBox="1"/>
          <p:nvPr/>
        </p:nvSpPr>
        <p:spPr>
          <a:xfrm>
            <a:off x="4888164" y="370277"/>
            <a:ext cx="302320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ajor Depressive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54" name="Google Shape;254;p19"/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atmaps showing the differentially expressed genes after Empirical Bayes analysis (raw p-value &lt; 0.05)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55" name="Google Shape;255;p19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69749" y="1685993"/>
            <a:ext cx="5442452" cy="3986866"/>
          </a:xfrm>
          <a:prstGeom prst="rect">
            <a:avLst/>
          </a:prstGeom>
          <a:noFill/>
          <a:ln>
            <a:noFill/>
          </a:ln>
        </p:spPr>
      </p:pic>
      <p:pic>
        <p:nvPicPr>
          <p:cNvPr id="256" name="Google Shape;256;p19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209879" y="1026367"/>
            <a:ext cx="5512372" cy="459364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Google Shape;97;p2"/>
          <p:cNvSpPr txBox="1"/>
          <p:nvPr/>
        </p:nvSpPr>
        <p:spPr>
          <a:xfrm>
            <a:off x="1823953" y="1026367"/>
            <a:ext cx="261610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) GSE18123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8" name="Google Shape;98;p2"/>
          <p:cNvSpPr txBox="1"/>
          <p:nvPr/>
        </p:nvSpPr>
        <p:spPr>
          <a:xfrm>
            <a:off x="4888164" y="370277"/>
            <a:ext cx="2989986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utism Spectrum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9" name="Google Shape;99;p2"/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atmaps showing the differentially expressed genes after Empirical Bayes analysis (raw p-value &lt; 0.05)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00" name="Google Shape;100;p2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97688" y="1457013"/>
            <a:ext cx="6001512" cy="4093137"/>
          </a:xfrm>
          <a:prstGeom prst="rect">
            <a:avLst/>
          </a:prstGeom>
          <a:noFill/>
          <a:ln>
            <a:noFill/>
          </a:ln>
        </p:spPr>
      </p:pic>
      <p:pic>
        <p:nvPicPr>
          <p:cNvPr id="101" name="Google Shape;101;p2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299200" y="1353659"/>
            <a:ext cx="5159812" cy="429984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Google Shape;106;p3"/>
          <p:cNvSpPr txBox="1"/>
          <p:nvPr/>
        </p:nvSpPr>
        <p:spPr>
          <a:xfrm>
            <a:off x="1823953" y="1026367"/>
            <a:ext cx="258885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) GSE25507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7" name="Google Shape;107;p3"/>
          <p:cNvSpPr txBox="1"/>
          <p:nvPr/>
        </p:nvSpPr>
        <p:spPr>
          <a:xfrm>
            <a:off x="4888164" y="370277"/>
            <a:ext cx="2989986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utism Spectrum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8" name="Google Shape;108;p3"/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atmaps showing the differentially expressed genes after Empirical Bayes analysis (raw p-value &lt; 0.05)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09" name="Google Shape;109;p3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10780" y="1546371"/>
            <a:ext cx="5972520" cy="4107953"/>
          </a:xfrm>
          <a:prstGeom prst="rect">
            <a:avLst/>
          </a:prstGeom>
          <a:noFill/>
          <a:ln>
            <a:noFill/>
          </a:ln>
        </p:spPr>
      </p:pic>
      <p:pic>
        <p:nvPicPr>
          <p:cNvPr id="110" name="Google Shape;110;p3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294257" y="1414478"/>
            <a:ext cx="4929545" cy="410795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4"/>
          <p:cNvSpPr txBox="1"/>
          <p:nvPr/>
        </p:nvSpPr>
        <p:spPr>
          <a:xfrm>
            <a:off x="1823953" y="1026367"/>
            <a:ext cx="261610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) GSE17612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6" name="Google Shape;116;p4"/>
          <p:cNvSpPr txBox="1"/>
          <p:nvPr/>
        </p:nvSpPr>
        <p:spPr>
          <a:xfrm>
            <a:off x="4888164" y="370277"/>
            <a:ext cx="167142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chizophrenia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7" name="Google Shape;117;p4"/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atmaps showing the differentially expressed genes after Empirical Bayes analysis (raw p-value &lt; 0.05)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18" name="Google Shape;118;p4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79188" y="1395698"/>
            <a:ext cx="5755213" cy="3976401"/>
          </a:xfrm>
          <a:prstGeom prst="rect">
            <a:avLst/>
          </a:prstGeom>
          <a:noFill/>
          <a:ln>
            <a:noFill/>
          </a:ln>
        </p:spPr>
      </p:pic>
      <p:pic>
        <p:nvPicPr>
          <p:cNvPr id="119" name="Google Shape;119;p4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5957568" y="1143792"/>
            <a:ext cx="5484499" cy="457041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Google Shape;124;p5"/>
          <p:cNvSpPr txBox="1"/>
          <p:nvPr/>
        </p:nvSpPr>
        <p:spPr>
          <a:xfrm>
            <a:off x="1823953" y="1026367"/>
            <a:ext cx="302187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) GSE62333 GEO dataset</a:t>
            </a:r>
            <a:endParaRPr sz="1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5" name="Google Shape;125;p5"/>
          <p:cNvSpPr txBox="1"/>
          <p:nvPr/>
        </p:nvSpPr>
        <p:spPr>
          <a:xfrm>
            <a:off x="4888164" y="370277"/>
            <a:ext cx="167142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chizophrenia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6" name="Google Shape;126;p5"/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atmaps showing the differentially expressed genes after Empirical Bayes analysis (raw p-value &lt; 0.05)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27" name="Google Shape;127;p5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69749" y="1765178"/>
            <a:ext cx="5509305" cy="3798601"/>
          </a:xfrm>
          <a:prstGeom prst="rect">
            <a:avLst/>
          </a:prstGeom>
          <a:noFill/>
          <a:ln>
            <a:noFill/>
          </a:ln>
        </p:spPr>
      </p:pic>
      <p:pic>
        <p:nvPicPr>
          <p:cNvPr id="128" name="Google Shape;128;p5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466948" y="1395699"/>
            <a:ext cx="4826317" cy="402193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Google Shape;134;p6"/>
          <p:cNvSpPr txBox="1"/>
          <p:nvPr/>
        </p:nvSpPr>
        <p:spPr>
          <a:xfrm>
            <a:off x="1823953" y="1026367"/>
            <a:ext cx="245278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) GSE5389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5" name="Google Shape;135;p6"/>
          <p:cNvSpPr txBox="1"/>
          <p:nvPr/>
        </p:nvSpPr>
        <p:spPr>
          <a:xfrm>
            <a:off x="4888164" y="370277"/>
            <a:ext cx="1893532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ipolar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6" name="Google Shape;136;p6"/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atmaps showing the differentially expressed genes after Empirical Bayes analysis (raw p-value &lt; 0.05)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37" name="Google Shape;137;p6"/>
          <p:cNvPicPr preferRelativeResize="0"/>
          <p:nvPr/>
        </p:nvPicPr>
        <p:blipFill rotWithShape="1">
          <a:blip r:embed="rId3">
            <a:alphaModFix/>
          </a:blip>
          <a:srcRect l="25782" t="-2676"/>
          <a:stretch/>
        </p:blipFill>
        <p:spPr>
          <a:xfrm>
            <a:off x="446184" y="1509734"/>
            <a:ext cx="5255258" cy="3775258"/>
          </a:xfrm>
          <a:prstGeom prst="rect">
            <a:avLst/>
          </a:prstGeom>
          <a:noFill/>
          <a:ln>
            <a:noFill/>
          </a:ln>
        </p:spPr>
      </p:pic>
      <p:pic>
        <p:nvPicPr>
          <p:cNvPr id="138" name="Google Shape;138;p6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5834930" y="1114484"/>
            <a:ext cx="5728420" cy="477368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Google Shape;143;p7"/>
          <p:cNvSpPr txBox="1"/>
          <p:nvPr/>
        </p:nvSpPr>
        <p:spPr>
          <a:xfrm>
            <a:off x="1823953" y="1026367"/>
            <a:ext cx="2484655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) GSE7036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4" name="Google Shape;144;p7"/>
          <p:cNvSpPr txBox="1"/>
          <p:nvPr/>
        </p:nvSpPr>
        <p:spPr>
          <a:xfrm>
            <a:off x="4888164" y="370277"/>
            <a:ext cx="1893532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ipolar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5" name="Google Shape;145;p7"/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atmaps showing the differentially expressed genes after Empirical Bayes analysis (raw p-value &lt; 0.05)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46" name="Google Shape;146;p7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6083300" y="1211032"/>
            <a:ext cx="5638951" cy="46991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47" name="Google Shape;147;p7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466709" y="1676352"/>
            <a:ext cx="5460331" cy="373384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Google Shape;152;p8"/>
          <p:cNvSpPr txBox="1"/>
          <p:nvPr/>
        </p:nvSpPr>
        <p:spPr>
          <a:xfrm>
            <a:off x="1823953" y="1026367"/>
            <a:ext cx="261610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) GSE12654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3" name="Google Shape;153;p8"/>
          <p:cNvSpPr txBox="1"/>
          <p:nvPr/>
        </p:nvSpPr>
        <p:spPr>
          <a:xfrm>
            <a:off x="4888164" y="370277"/>
            <a:ext cx="167142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chizophrenia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4" name="Google Shape;154;p8"/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atmaps showing the differentially expressed genes after Empirical Bayes analysis (raw p-value &lt; 0.05)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55" name="Google Shape;155;p8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69749" y="1395699"/>
            <a:ext cx="5610108" cy="4032644"/>
          </a:xfrm>
          <a:prstGeom prst="rect">
            <a:avLst/>
          </a:prstGeom>
          <a:noFill/>
          <a:ln>
            <a:noFill/>
          </a:ln>
        </p:spPr>
      </p:pic>
      <p:pic>
        <p:nvPicPr>
          <p:cNvPr id="156" name="Google Shape;156;p8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356941" y="1211033"/>
            <a:ext cx="4987330" cy="415610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Google Shape;161;p9"/>
          <p:cNvSpPr txBox="1"/>
          <p:nvPr/>
        </p:nvSpPr>
        <p:spPr>
          <a:xfrm>
            <a:off x="1823953" y="1026367"/>
            <a:ext cx="258885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) GSE12654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2" name="Google Shape;162;p9"/>
          <p:cNvSpPr txBox="1"/>
          <p:nvPr/>
        </p:nvSpPr>
        <p:spPr>
          <a:xfrm>
            <a:off x="4888164" y="370277"/>
            <a:ext cx="1893532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ipolar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3" name="Google Shape;163;p9"/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atmaps showing the differentially expressed genes after Empirical Bayes analysis (raw p-value &lt; 0.05) (left) </a:t>
            </a:r>
            <a:r>
              <a:rPr lang="en-US" sz="14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en-US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differentially expressed genes after Comparative Analysis of Shapley value analysis (p-value &lt; 0.01) (right).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64" name="Google Shape;164;p9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21794" y="1395698"/>
            <a:ext cx="5873230" cy="42586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65" name="Google Shape;165;p9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201198" y="1026367"/>
            <a:ext cx="5530260" cy="460855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98</Words>
  <Application>Microsoft Office PowerPoint</Application>
  <PresentationFormat>Panorámica</PresentationFormat>
  <Paragraphs>60</Paragraphs>
  <Slides>19</Slides>
  <Notes>19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9</vt:i4>
      </vt:variant>
    </vt:vector>
  </HeadingPairs>
  <TitlesOfParts>
    <vt:vector size="22" baseType="lpstr">
      <vt:lpstr>Arial</vt:lpstr>
      <vt:lpstr>Calibri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Windows User</dc:creator>
  <cp:lastModifiedBy>Windows User</cp:lastModifiedBy>
  <cp:revision>1</cp:revision>
  <dcterms:created xsi:type="dcterms:W3CDTF">2024-05-16T14:56:22Z</dcterms:created>
  <dcterms:modified xsi:type="dcterms:W3CDTF">2024-10-16T10:33:37Z</dcterms:modified>
</cp:coreProperties>
</file>